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ACE2235-FF97-AA4F-9E39-ADE65E0122F2}" v="2" dt="2023-08-31T06:43:24.91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3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 PAN (20567662)" userId="bcbb93bd-4ab9-4583-a92c-85cf909a14d6" providerId="ADAL" clId="{CACE2235-FF97-AA4F-9E39-ADE65E0122F2}"/>
    <pc:docChg chg="custSel modSld">
      <pc:chgData name="Qi PAN (20567662)" userId="bcbb93bd-4ab9-4583-a92c-85cf909a14d6" providerId="ADAL" clId="{CACE2235-FF97-AA4F-9E39-ADE65E0122F2}" dt="2023-08-31T06:43:37.107" v="72" actId="1076"/>
      <pc:docMkLst>
        <pc:docMk/>
      </pc:docMkLst>
      <pc:sldChg chg="addSp delSp modSp mod">
        <pc:chgData name="Qi PAN (20567662)" userId="bcbb93bd-4ab9-4583-a92c-85cf909a14d6" providerId="ADAL" clId="{CACE2235-FF97-AA4F-9E39-ADE65E0122F2}" dt="2023-08-31T06:43:37.107" v="72" actId="1076"/>
        <pc:sldMkLst>
          <pc:docMk/>
          <pc:sldMk cId="2533011358" sldId="256"/>
        </pc:sldMkLst>
        <pc:spChg chg="add mod">
          <ac:chgData name="Qi PAN (20567662)" userId="bcbb93bd-4ab9-4583-a92c-85cf909a14d6" providerId="ADAL" clId="{CACE2235-FF97-AA4F-9E39-ADE65E0122F2}" dt="2023-08-31T06:43:37.107" v="72" actId="1076"/>
          <ac:spMkLst>
            <pc:docMk/>
            <pc:sldMk cId="2533011358" sldId="256"/>
            <ac:spMk id="2" creationId="{2CC2B3E7-3187-D27D-EA6A-99DF0FCC3F62}"/>
          </ac:spMkLst>
        </pc:spChg>
        <pc:picChg chg="del">
          <ac:chgData name="Qi PAN (20567662)" userId="bcbb93bd-4ab9-4583-a92c-85cf909a14d6" providerId="ADAL" clId="{CACE2235-FF97-AA4F-9E39-ADE65E0122F2}" dt="2023-08-31T06:42:03.455" v="66" actId="478"/>
          <ac:picMkLst>
            <pc:docMk/>
            <pc:sldMk cId="2533011358" sldId="256"/>
            <ac:picMk id="3" creationId="{E2229CD2-EA73-0613-7BDB-EB73D149A2C2}"/>
          </ac:picMkLst>
        </pc:picChg>
        <pc:picChg chg="add mod">
          <ac:chgData name="Qi PAN (20567662)" userId="bcbb93bd-4ab9-4583-a92c-85cf909a14d6" providerId="ADAL" clId="{CACE2235-FF97-AA4F-9E39-ADE65E0122F2}" dt="2023-08-31T06:43:31.790" v="71" actId="1076"/>
          <ac:picMkLst>
            <pc:docMk/>
            <pc:sldMk cId="2533011358" sldId="256"/>
            <ac:picMk id="4" creationId="{14218DF8-69B1-D8FA-DE95-C8D056FFDFD5}"/>
          </ac:picMkLst>
        </pc:picChg>
      </pc:sldChg>
    </pc:docChg>
  </pc:docChgLst>
  <pc:docChgLst>
    <pc:chgData name="Qi PAN (20567662)" userId="bcbb93bd-4ab9-4583-a92c-85cf909a14d6" providerId="ADAL" clId="{AEDEA0CC-8BEA-8041-8689-A4BAD8D5B804}"/>
    <pc:docChg chg="undo custSel modSld">
      <pc:chgData name="Qi PAN (20567662)" userId="bcbb93bd-4ab9-4583-a92c-85cf909a14d6" providerId="ADAL" clId="{AEDEA0CC-8BEA-8041-8689-A4BAD8D5B804}" dt="2023-08-25T02:15:49.007" v="15" actId="1076"/>
      <pc:docMkLst>
        <pc:docMk/>
      </pc:docMkLst>
      <pc:sldChg chg="addSp delSp modSp mod">
        <pc:chgData name="Qi PAN (20567662)" userId="bcbb93bd-4ab9-4583-a92c-85cf909a14d6" providerId="ADAL" clId="{AEDEA0CC-8BEA-8041-8689-A4BAD8D5B804}" dt="2023-08-25T02:15:49.007" v="15" actId="1076"/>
        <pc:sldMkLst>
          <pc:docMk/>
          <pc:sldMk cId="2533011358" sldId="256"/>
        </pc:sldMkLst>
        <pc:spChg chg="add del mod">
          <ac:chgData name="Qi PAN (20567662)" userId="bcbb93bd-4ab9-4583-a92c-85cf909a14d6" providerId="ADAL" clId="{AEDEA0CC-8BEA-8041-8689-A4BAD8D5B804}" dt="2023-08-25T02:15:28.956" v="10" actId="22"/>
          <ac:spMkLst>
            <pc:docMk/>
            <pc:sldMk cId="2533011358" sldId="256"/>
            <ac:spMk id="5" creationId="{54710732-76CC-4086-89E8-2D91E89C1E64}"/>
          </ac:spMkLst>
        </pc:spChg>
        <pc:picChg chg="del">
          <ac:chgData name="Qi PAN (20567662)" userId="bcbb93bd-4ab9-4583-a92c-85cf909a14d6" providerId="ADAL" clId="{AEDEA0CC-8BEA-8041-8689-A4BAD8D5B804}" dt="2023-08-25T02:14:47.342" v="0" actId="478"/>
          <ac:picMkLst>
            <pc:docMk/>
            <pc:sldMk cId="2533011358" sldId="256"/>
            <ac:picMk id="2" creationId="{66C0E6F0-3D4B-F599-06FD-3A9A281A48B7}"/>
          </ac:picMkLst>
        </pc:picChg>
        <pc:picChg chg="add mod">
          <ac:chgData name="Qi PAN (20567662)" userId="bcbb93bd-4ab9-4583-a92c-85cf909a14d6" providerId="ADAL" clId="{AEDEA0CC-8BEA-8041-8689-A4BAD8D5B804}" dt="2023-08-25T02:15:49.007" v="15" actId="1076"/>
          <ac:picMkLst>
            <pc:docMk/>
            <pc:sldMk cId="2533011358" sldId="256"/>
            <ac:picMk id="3" creationId="{E2229CD2-EA73-0613-7BDB-EB73D149A2C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75DE37-DAB8-524A-36CE-1F562359EA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2227BDA-50A8-02E3-9C62-B89E3720EF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EAE99A-E347-8CED-CC4F-F23F7D5AD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5417AC-7E91-1791-FB35-B12E17481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C00D39-797D-920A-780E-86962487E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993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A6F028-A2D6-CAAE-B01E-6F9D86C2B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FC735B-3A6B-3BD8-83D7-8EE0E51A56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CDAB94-5493-FAFF-FE7A-6C2DADD7D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36C8A1-EA51-787D-5869-00704B267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2B64E8-C9A8-FFF3-2A70-198F5869D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657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5DC3CFE-78B5-822E-7110-AB13E3CAA3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34B1FF-A3EB-F259-1F18-5BA208A84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F72761-F59D-E592-D7F4-93CFA5F1F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98B963-DB60-4D4C-7D72-115CCA33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2A720C-79F0-6617-C76B-9D3FD4711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771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E59864-36AB-0B12-F17F-E00E98B29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794DE2-740E-638F-F417-BD95C11B50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8DD750-029A-DF56-2489-2AE6AB769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6D0A24-B7ED-0BB4-75E5-75EE2CE41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B41BC5-6D2E-6C4B-1973-A378C3F4C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70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2963ED-E577-B192-2186-2BA719E39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AA342B-5D57-A3AA-EDB3-5074CBFA40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9D6DBC-C01A-8EB0-3AEB-163731B6C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9A19EF-765B-AA1B-B984-94053B0B6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88D3D-AB20-1C40-52F8-CBEF0A45B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755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DCBAED-E3E4-ED56-4DC3-25B664130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DE79B8D-7A21-E232-0396-FB92ED45E4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CBE58E5-3F41-AACF-F07B-1DFC8C9C09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243D13-DC3F-9BCF-06AE-FA0973994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791BCD-AD75-6BF9-7B38-60FC89116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D156C0-FBE9-45D7-1C7D-E34576DEA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18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55ECCE-25A2-C4A1-CFC0-EEB68A3EA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31AF53-E7AF-61A2-BC88-CB69F1812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48E305-08E4-26B5-8103-5E6D4D0830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8F03C23-3682-F820-9014-C9E3BF8D9D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F98E60-F718-0062-2164-22EFE04CAB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A350F3D-8BDE-2FF5-39DC-A394F0CE6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3949AC5-9685-53AD-6042-083D15AD3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92F02D5-5985-E9CF-937D-B4DDE7EA5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65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3B95C7-DF33-F499-0655-5631B4A61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DC79ABC-95AB-06A5-2F16-4AAD95DC8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BE7D470-6C20-F89D-CD2F-F4DF2F8AC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3371AB3-B251-1A96-2928-BE5E85734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274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13F258-4F81-CDC7-5235-44EB1FB7E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D432ED2-32D0-77DE-43CA-ECF6F7AE2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D1A4048-829B-F19F-7A4C-B15332F78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71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A2BAC1-58DA-C371-ECA9-9463D6BD3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EC84DD-276D-9989-14E1-9B0F6A847A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A21B89A-DEA1-C529-8231-242D7F339C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A8B0EE-6A4F-9CB8-5240-57797DF0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8B5ECE-EBAC-80A3-2C8D-862198511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7EC5A5-2365-957D-E501-A55D3117D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814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2969AF-6949-52F3-6720-C45C0E00CC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C38E1B7-2E58-B481-3D60-EE19E0BA84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1A0364A-44C5-129E-63F6-9486B2B005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2451A6-382A-FE67-4B60-DB6EC9775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F9F63F-74A5-F4E9-0FA1-EA7F430F3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C29F02-4977-BED6-652A-9B4457F7E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491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C3BFC56-3306-42DF-9593-8A63D2B69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3064B6-ECAF-592E-ECEB-1EEFB91471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E109A8-FA92-CA31-1C35-AFFBAFD66C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E9BF3-2A24-4369-B2C5-666C8D80FF10}" type="datetimeFigureOut">
              <a:rPr lang="zh-CN" altLang="en-US" smtClean="0"/>
              <a:t>2023/8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F0F29F-0353-A97D-4E01-C099B4F979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621E45-031D-1655-5AA7-E5A8504209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664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CC2B3E7-3187-D27D-EA6A-99DF0FCC3F62}"/>
              </a:ext>
            </a:extLst>
          </p:cNvPr>
          <p:cNvSpPr txBox="1"/>
          <p:nvPr/>
        </p:nvSpPr>
        <p:spPr>
          <a:xfrm>
            <a:off x="613252" y="6196418"/>
            <a:ext cx="10965494" cy="3737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algn="ctr">
              <a:lnSpc>
                <a:spcPct val="107000"/>
              </a:lnSpc>
              <a:spcAft>
                <a:spcPts val="800"/>
              </a:spcAft>
            </a:pPr>
            <a:r>
              <a:rPr lang="en-US" altLang="zh-CN" sz="18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Vrinda" panose="020B0502040204020203" pitchFamily="34" charset="0"/>
              </a:rPr>
              <a:t>Supplementary Figure 4</a:t>
            </a:r>
            <a:r>
              <a:rPr lang="en-US" altLang="zh-CN" sz="18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Vrinda" panose="020B0502040204020203" pitchFamily="34" charset="0"/>
              </a:rPr>
              <a:t> The Manhattan plots of GWAS on hip pain vs no hip pain using UK biobank</a:t>
            </a:r>
            <a:endParaRPr lang="zh-CN" altLang="zh-CN" sz="18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Vrinda" panose="020B0502040204020203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4218DF8-69B1-D8FA-DE95-C8D056FFDF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654" y="891283"/>
            <a:ext cx="11748691" cy="5075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011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</Words>
  <Application>Microsoft Macintosh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hua.meng</dc:creator>
  <cp:lastModifiedBy>Pan, Qi</cp:lastModifiedBy>
  <cp:revision>3</cp:revision>
  <dcterms:created xsi:type="dcterms:W3CDTF">2022-08-21T00:56:49Z</dcterms:created>
  <dcterms:modified xsi:type="dcterms:W3CDTF">2023-08-31T06:43:38Z</dcterms:modified>
</cp:coreProperties>
</file>